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  <p:sldId id="267" r:id="rId12"/>
    <p:sldId id="268" r:id="rId13"/>
    <p:sldId id="269" r:id="rId14"/>
    <p:sldId id="270" r:id="rId15"/>
    <p:sldId id="271" r:id="rId16"/>
    <p:sldId id="272" r:id="rId17"/>
    <p:sldId id="273" r:id="rId18"/>
    <p:sldId id="274" r:id="rId19"/>
    <p:sldId id="275" r:id="rId20"/>
    <p:sldId id="276" r:id="rId21"/>
    <p:sldId id="277" r:id="rId22"/>
    <p:sldId id="278" r:id="rId23"/>
    <p:sldId id="279" r:id="rId24"/>
  </p:sldIdLst>
  <p:sldSz cx="12192000" cy="6858000"/>
  <p:notesSz cx="6858000" cy="9144000"/>
  <p:defaultTextStyle>
    <a:defPPr>
      <a:defRPr lang="nl-B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45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viewProps" Target="viewProp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 smtClean="0"/>
              <a:t>Klik om de stijl te bewerken</a:t>
            </a:r>
            <a:endParaRPr lang="en-GB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 smtClean="0"/>
              <a:t>Klik om de ondertitelstijl van het model te bewerken</a:t>
            </a:r>
            <a:endParaRPr lang="en-GB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74D26-FF84-43FA-A68C-4C8607A567BF}" type="datetimeFigureOut">
              <a:rPr lang="en-GB" smtClean="0"/>
              <a:t>09/09/2020</a:t>
            </a:fld>
            <a:endParaRPr lang="en-GB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A61C6-1119-41FA-8C29-C91CA12243F0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787988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en-GB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GB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74D26-FF84-43FA-A68C-4C8607A567BF}" type="datetimeFigureOut">
              <a:rPr lang="en-GB" smtClean="0"/>
              <a:t>09/09/2020</a:t>
            </a:fld>
            <a:endParaRPr lang="en-GB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A61C6-1119-41FA-8C29-C91CA12243F0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6399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l-NL" smtClean="0"/>
              <a:t>Klik om de stijl te bewerken</a:t>
            </a:r>
            <a:endParaRPr lang="en-GB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GB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74D26-FF84-43FA-A68C-4C8607A567BF}" type="datetimeFigureOut">
              <a:rPr lang="en-GB" smtClean="0"/>
              <a:t>09/09/2020</a:t>
            </a:fld>
            <a:endParaRPr lang="en-GB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A61C6-1119-41FA-8C29-C91CA12243F0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80661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en-GB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GB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74D26-FF84-43FA-A68C-4C8607A567BF}" type="datetimeFigureOut">
              <a:rPr lang="en-GB" smtClean="0"/>
              <a:t>09/09/2020</a:t>
            </a:fld>
            <a:endParaRPr lang="en-GB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A61C6-1119-41FA-8C29-C91CA12243F0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81568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 smtClean="0"/>
              <a:t>Klik om de stijl te bewerken</a:t>
            </a:r>
            <a:endParaRPr lang="en-GB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74D26-FF84-43FA-A68C-4C8607A567BF}" type="datetimeFigureOut">
              <a:rPr lang="en-GB" smtClean="0"/>
              <a:t>09/09/2020</a:t>
            </a:fld>
            <a:endParaRPr lang="en-GB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A61C6-1119-41FA-8C29-C91CA12243F0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93978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en-GB"/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GB"/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GB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74D26-FF84-43FA-A68C-4C8607A567BF}" type="datetimeFigureOut">
              <a:rPr lang="en-GB" smtClean="0"/>
              <a:t>09/09/2020</a:t>
            </a:fld>
            <a:endParaRPr lang="en-GB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A61C6-1119-41FA-8C29-C91CA12243F0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37675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en-GB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GB"/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GB"/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74D26-FF84-43FA-A68C-4C8607A567BF}" type="datetimeFigureOut">
              <a:rPr lang="en-GB" smtClean="0"/>
              <a:t>09/09/2020</a:t>
            </a:fld>
            <a:endParaRPr lang="en-GB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A61C6-1119-41FA-8C29-C91CA12243F0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26200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en-GB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74D26-FF84-43FA-A68C-4C8607A567BF}" type="datetimeFigureOut">
              <a:rPr lang="en-GB" smtClean="0"/>
              <a:t>09/09/2020</a:t>
            </a:fld>
            <a:endParaRPr lang="en-GB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A61C6-1119-41FA-8C29-C91CA12243F0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68359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74D26-FF84-43FA-A68C-4C8607A567BF}" type="datetimeFigureOut">
              <a:rPr lang="en-GB" smtClean="0"/>
              <a:t>09/09/2020</a:t>
            </a:fld>
            <a:endParaRPr lang="en-GB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A61C6-1119-41FA-8C29-C91CA12243F0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4839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 smtClean="0"/>
              <a:t>Klik om de stijl te bewerken</a:t>
            </a:r>
            <a:endParaRPr lang="en-GB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GB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74D26-FF84-43FA-A68C-4C8607A567BF}" type="datetimeFigureOut">
              <a:rPr lang="en-GB" smtClean="0"/>
              <a:t>09/09/2020</a:t>
            </a:fld>
            <a:endParaRPr lang="en-GB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A61C6-1119-41FA-8C29-C91CA12243F0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04456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 smtClean="0"/>
              <a:t>Klik om de stijl te bewerken</a:t>
            </a:r>
            <a:endParaRPr lang="en-GB"/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74D26-FF84-43FA-A68C-4C8607A567BF}" type="datetimeFigureOut">
              <a:rPr lang="en-GB" smtClean="0"/>
              <a:t>09/09/2020</a:t>
            </a:fld>
            <a:endParaRPr lang="en-GB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A61C6-1119-41FA-8C29-C91CA12243F0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02130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 smtClean="0"/>
              <a:t>Klik om de stijl te bewerken</a:t>
            </a:r>
            <a:endParaRPr lang="en-GB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GB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D74D26-FF84-43FA-A68C-4C8607A567BF}" type="datetimeFigureOut">
              <a:rPr lang="en-GB" smtClean="0"/>
              <a:t>09/09/2020</a:t>
            </a:fld>
            <a:endParaRPr lang="en-GB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6A61C6-1119-41FA-8C29-C91CA12243F0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14084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B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60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43071" y="1290140"/>
            <a:ext cx="6927242" cy="44050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5604" name="Tekstvak 3"/>
          <p:cNvSpPr txBox="1">
            <a:spLocks noChangeArrowheads="1"/>
          </p:cNvSpPr>
          <p:nvPr/>
        </p:nvSpPr>
        <p:spPr bwMode="auto">
          <a:xfrm>
            <a:off x="2033131" y="390939"/>
            <a:ext cx="8333463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nl-BE" sz="1200" b="1" dirty="0"/>
              <a:t>Figures S2a</a:t>
            </a:r>
          </a:p>
          <a:p>
            <a:r>
              <a:rPr lang="en-GB" altLang="nl-BE" sz="1200" dirty="0" smtClean="0"/>
              <a:t>Bland-Altman plots for the </a:t>
            </a:r>
            <a:r>
              <a:rPr lang="en-GB" altLang="nl-BE" sz="1200" u="sng" dirty="0" smtClean="0"/>
              <a:t>dietary </a:t>
            </a:r>
            <a:r>
              <a:rPr lang="en-GB" altLang="nl-BE" sz="1200" u="sng" dirty="0"/>
              <a:t>questionnaire </a:t>
            </a:r>
            <a:r>
              <a:rPr lang="en-GB" altLang="nl-BE" sz="1200" dirty="0"/>
              <a:t>(DQ) data representing the mean differences and their limits of agreement for water intakes (g/day) between </a:t>
            </a:r>
            <a:r>
              <a:rPr lang="en-GB" altLang="nl-BE" sz="1200" dirty="0" smtClean="0"/>
              <a:t>the U.S. nutrient database (USNDB) and the </a:t>
            </a:r>
            <a:r>
              <a:rPr lang="en-GB" altLang="nl-BE" sz="1200" dirty="0"/>
              <a:t>EPIC nutrient database (ENDB</a:t>
            </a:r>
            <a:r>
              <a:rPr lang="en-GB" altLang="nl-BE" sz="1200" dirty="0" smtClean="0"/>
              <a:t>). </a:t>
            </a:r>
            <a:r>
              <a:rPr lang="en-GB" altLang="nl-BE" sz="1200" dirty="0"/>
              <a:t>The mean difference is represented by the full line, upper and lower limit of agreement are presented by dotted lines.</a:t>
            </a:r>
          </a:p>
        </p:txBody>
      </p:sp>
      <p:sp>
        <p:nvSpPr>
          <p:cNvPr id="4" name="Tekstvak 3"/>
          <p:cNvSpPr txBox="1"/>
          <p:nvPr/>
        </p:nvSpPr>
        <p:spPr>
          <a:xfrm>
            <a:off x="3683479" y="5382875"/>
            <a:ext cx="558129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/>
              <a:t>mean water intake (g/day): (USNDB mean + ENDB mean)/2</a:t>
            </a:r>
            <a:endParaRPr lang="en-GB" sz="1200" dirty="0"/>
          </a:p>
        </p:txBody>
      </p:sp>
      <p:sp>
        <p:nvSpPr>
          <p:cNvPr id="5" name="Tekstvak 4"/>
          <p:cNvSpPr txBox="1"/>
          <p:nvPr/>
        </p:nvSpPr>
        <p:spPr>
          <a:xfrm rot="16200000">
            <a:off x="1117782" y="3114286"/>
            <a:ext cx="3362326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m</a:t>
            </a:r>
            <a:r>
              <a:rPr lang="en-GB" sz="1200" dirty="0" smtClean="0"/>
              <a:t>ean difference in water intake (g/day)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11651446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818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27409" y="1624130"/>
            <a:ext cx="6927242" cy="40781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4819" name="Tekstvak 3"/>
          <p:cNvSpPr txBox="1">
            <a:spLocks noChangeArrowheads="1"/>
          </p:cNvSpPr>
          <p:nvPr/>
        </p:nvSpPr>
        <p:spPr bwMode="auto">
          <a:xfrm>
            <a:off x="2033131" y="393049"/>
            <a:ext cx="8333463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nl-BE" sz="1200" b="1" dirty="0" smtClean="0"/>
              <a:t>Figures S2j</a:t>
            </a:r>
          </a:p>
          <a:p>
            <a:r>
              <a:rPr lang="en-GB" altLang="nl-BE" sz="1200" dirty="0" smtClean="0"/>
              <a:t>Bland-Altman plots for the </a:t>
            </a:r>
            <a:r>
              <a:rPr lang="en-GB" altLang="nl-BE" sz="1200" u="sng" dirty="0" smtClean="0"/>
              <a:t>dietary </a:t>
            </a:r>
            <a:r>
              <a:rPr lang="en-GB" altLang="nl-BE" sz="1200" u="sng" dirty="0"/>
              <a:t>questionnaire </a:t>
            </a:r>
            <a:r>
              <a:rPr lang="en-GB" altLang="nl-BE" sz="1200" dirty="0"/>
              <a:t>(DQ) data representing the mean differences and their limits of agreement for iron intakes (mg/day) between the U.S. nutrient database </a:t>
            </a:r>
            <a:r>
              <a:rPr lang="en-GB" altLang="nl-BE" sz="1200" dirty="0" smtClean="0"/>
              <a:t>(USNDB) </a:t>
            </a:r>
            <a:r>
              <a:rPr lang="en-GB" altLang="nl-BE" sz="1200" dirty="0"/>
              <a:t>and the EPIC nutrient database (</a:t>
            </a:r>
            <a:r>
              <a:rPr lang="en-GB" altLang="nl-BE" sz="1200" dirty="0" smtClean="0"/>
              <a:t>ENDB). The </a:t>
            </a:r>
            <a:r>
              <a:rPr lang="en-GB" altLang="nl-BE" sz="1200" dirty="0"/>
              <a:t>mean difference is represented by the full line, upper and lower limit of agreement are presented by dotted lines.</a:t>
            </a:r>
          </a:p>
        </p:txBody>
      </p:sp>
      <p:sp>
        <p:nvSpPr>
          <p:cNvPr id="5" name="Tekstvak 4"/>
          <p:cNvSpPr txBox="1"/>
          <p:nvPr/>
        </p:nvSpPr>
        <p:spPr>
          <a:xfrm>
            <a:off x="3295650" y="5401925"/>
            <a:ext cx="557859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/>
              <a:t>mean iron intake (mg/day): (USNDB mean + ENDB mean)/2</a:t>
            </a:r>
            <a:endParaRPr lang="en-GB" sz="1200" dirty="0"/>
          </a:p>
        </p:txBody>
      </p:sp>
      <p:sp>
        <p:nvSpPr>
          <p:cNvPr id="6" name="Tekstvak 5"/>
          <p:cNvSpPr txBox="1"/>
          <p:nvPr/>
        </p:nvSpPr>
        <p:spPr>
          <a:xfrm rot="16200000">
            <a:off x="870133" y="3104761"/>
            <a:ext cx="330517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m</a:t>
            </a:r>
            <a:r>
              <a:rPr lang="en-GB" sz="1200" dirty="0" smtClean="0"/>
              <a:t>ean difference in iron intake (mg/day)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85825564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84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81378" y="1614965"/>
            <a:ext cx="6927242" cy="40781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5843" name="Tekstvak 3"/>
          <p:cNvSpPr txBox="1">
            <a:spLocks noChangeArrowheads="1"/>
          </p:cNvSpPr>
          <p:nvPr/>
        </p:nvSpPr>
        <p:spPr bwMode="auto">
          <a:xfrm>
            <a:off x="2033131" y="393049"/>
            <a:ext cx="8333463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nl-BE" sz="1200" b="1" dirty="0" smtClean="0"/>
              <a:t>Figures S2k</a:t>
            </a:r>
          </a:p>
          <a:p>
            <a:r>
              <a:rPr lang="en-GB" altLang="nl-BE" sz="1200" dirty="0" smtClean="0"/>
              <a:t>Bland-Altman plots for the </a:t>
            </a:r>
            <a:r>
              <a:rPr lang="en-GB" altLang="nl-BE" sz="1200" u="sng" dirty="0" smtClean="0"/>
              <a:t>dietary </a:t>
            </a:r>
            <a:r>
              <a:rPr lang="en-GB" altLang="nl-BE" sz="1200" u="sng" dirty="0"/>
              <a:t>questionnaire </a:t>
            </a:r>
            <a:r>
              <a:rPr lang="en-GB" altLang="nl-BE" sz="1200" dirty="0"/>
              <a:t>(DQ) data representing the mean differences and their limits of agreement for potassium intakes (mg/day) between the U.S. nutrient database </a:t>
            </a:r>
            <a:r>
              <a:rPr lang="en-GB" altLang="nl-BE" sz="1200" dirty="0" smtClean="0"/>
              <a:t>(USNDB) </a:t>
            </a:r>
            <a:r>
              <a:rPr lang="en-GB" altLang="nl-BE" sz="1200" dirty="0"/>
              <a:t>and the EPIC nutrient database (ENDB</a:t>
            </a:r>
            <a:r>
              <a:rPr lang="en-GB" altLang="nl-BE" sz="1200" dirty="0" smtClean="0"/>
              <a:t>). </a:t>
            </a:r>
            <a:r>
              <a:rPr lang="en-GB" altLang="nl-BE" sz="1200" dirty="0"/>
              <a:t>The mean difference is represented by the full line, upper and lower limit of agreement are presented by dotted lines.</a:t>
            </a:r>
          </a:p>
        </p:txBody>
      </p:sp>
      <p:sp>
        <p:nvSpPr>
          <p:cNvPr id="5" name="Tekstvak 4"/>
          <p:cNvSpPr txBox="1"/>
          <p:nvPr/>
        </p:nvSpPr>
        <p:spPr>
          <a:xfrm>
            <a:off x="3467100" y="5401925"/>
            <a:ext cx="557859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/>
              <a:t>mean potassium intake (mg/day): (USNDB mean + ENDB mean)/2</a:t>
            </a:r>
            <a:endParaRPr lang="en-GB" sz="1200" dirty="0"/>
          </a:p>
        </p:txBody>
      </p:sp>
      <p:sp>
        <p:nvSpPr>
          <p:cNvPr id="6" name="Tekstvak 5"/>
          <p:cNvSpPr txBox="1"/>
          <p:nvPr/>
        </p:nvSpPr>
        <p:spPr>
          <a:xfrm rot="16200000">
            <a:off x="951094" y="3300026"/>
            <a:ext cx="327660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m</a:t>
            </a:r>
            <a:r>
              <a:rPr lang="en-GB" sz="1200" dirty="0" smtClean="0"/>
              <a:t>ean difference in potassium intake (mg/day)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319273174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866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6181" y="1588490"/>
            <a:ext cx="6927242" cy="40781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6867" name="Tekstvak 3"/>
          <p:cNvSpPr txBox="1">
            <a:spLocks noChangeArrowheads="1"/>
          </p:cNvSpPr>
          <p:nvPr/>
        </p:nvSpPr>
        <p:spPr bwMode="auto">
          <a:xfrm>
            <a:off x="2033131" y="393049"/>
            <a:ext cx="8333463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nl-BE" sz="1200" b="1" dirty="0" smtClean="0"/>
              <a:t>Figures S2l</a:t>
            </a:r>
          </a:p>
          <a:p>
            <a:r>
              <a:rPr lang="en-GB" altLang="nl-BE" sz="1200" dirty="0" smtClean="0"/>
              <a:t>Bland-Altman plots for the </a:t>
            </a:r>
            <a:r>
              <a:rPr lang="en-GB" altLang="nl-BE" sz="1200" u="sng" dirty="0" smtClean="0"/>
              <a:t>dietary </a:t>
            </a:r>
            <a:r>
              <a:rPr lang="en-GB" altLang="nl-BE" sz="1200" u="sng" dirty="0"/>
              <a:t>questionnaire </a:t>
            </a:r>
            <a:r>
              <a:rPr lang="en-GB" altLang="nl-BE" sz="1200" dirty="0"/>
              <a:t>(DQ) data representing the mean differences and their limits of agreement for magnesium intakes (mg/day) between the U.S. nutrient database </a:t>
            </a:r>
            <a:r>
              <a:rPr lang="en-GB" altLang="nl-BE" sz="1200" dirty="0" smtClean="0"/>
              <a:t>(USNDB) </a:t>
            </a:r>
            <a:r>
              <a:rPr lang="en-GB" altLang="nl-BE" sz="1200" dirty="0"/>
              <a:t>and the EPIC nutrient database (</a:t>
            </a:r>
            <a:r>
              <a:rPr lang="en-GB" altLang="nl-BE" sz="1200" dirty="0" smtClean="0"/>
              <a:t>ENDB). </a:t>
            </a:r>
            <a:r>
              <a:rPr lang="en-GB" altLang="nl-BE" sz="1200" dirty="0"/>
              <a:t>The mean difference is represented by the full line, upper and lower limit of agreement are presented by dotted lines.</a:t>
            </a:r>
          </a:p>
        </p:txBody>
      </p:sp>
      <p:sp>
        <p:nvSpPr>
          <p:cNvPr id="5" name="Tekstvak 4"/>
          <p:cNvSpPr txBox="1"/>
          <p:nvPr/>
        </p:nvSpPr>
        <p:spPr>
          <a:xfrm>
            <a:off x="3476625" y="5392400"/>
            <a:ext cx="557859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/>
              <a:t>mean magnesium intake (</a:t>
            </a:r>
            <a:r>
              <a:rPr lang="en-GB" sz="1200" dirty="0"/>
              <a:t>m</a:t>
            </a:r>
            <a:r>
              <a:rPr lang="en-GB" sz="1200" dirty="0" smtClean="0"/>
              <a:t>g/day): (USNDB mean + ENDB mean)/2</a:t>
            </a:r>
            <a:endParaRPr lang="en-GB" sz="1200" dirty="0"/>
          </a:p>
        </p:txBody>
      </p:sp>
      <p:sp>
        <p:nvSpPr>
          <p:cNvPr id="6" name="Tekstvak 5"/>
          <p:cNvSpPr txBox="1"/>
          <p:nvPr/>
        </p:nvSpPr>
        <p:spPr>
          <a:xfrm rot="16200000">
            <a:off x="1013008" y="3276211"/>
            <a:ext cx="320992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m</a:t>
            </a:r>
            <a:r>
              <a:rPr lang="en-GB" sz="1200" dirty="0" smtClean="0"/>
              <a:t>ean difference in magnesium intake (mg/day)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189024083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7890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99706" y="1750395"/>
            <a:ext cx="6927242" cy="40781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7891" name="Tekstvak 3"/>
          <p:cNvSpPr txBox="1">
            <a:spLocks noChangeArrowheads="1"/>
          </p:cNvSpPr>
          <p:nvPr/>
        </p:nvSpPr>
        <p:spPr bwMode="auto">
          <a:xfrm>
            <a:off x="2033131" y="393049"/>
            <a:ext cx="8333463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nl-BE" sz="1200" b="1" dirty="0" smtClean="0"/>
              <a:t>Figures S2m</a:t>
            </a:r>
          </a:p>
          <a:p>
            <a:r>
              <a:rPr lang="en-GB" altLang="nl-BE" sz="1200" dirty="0" smtClean="0"/>
              <a:t>Bland-Altman plots for the </a:t>
            </a:r>
            <a:r>
              <a:rPr lang="en-GB" altLang="nl-BE" sz="1200" u="sng" dirty="0" smtClean="0"/>
              <a:t>dietary </a:t>
            </a:r>
            <a:r>
              <a:rPr lang="en-GB" altLang="nl-BE" sz="1200" u="sng" dirty="0"/>
              <a:t>questionnaire </a:t>
            </a:r>
            <a:r>
              <a:rPr lang="en-GB" altLang="nl-BE" sz="1200" dirty="0"/>
              <a:t>(DQ) data representing the mean differences and their limits of agreement for phosphorus intakes (mg/day) between the U.S. nutrient database </a:t>
            </a:r>
            <a:r>
              <a:rPr lang="en-GB" altLang="nl-BE" sz="1200" dirty="0" smtClean="0"/>
              <a:t>(USNDB) </a:t>
            </a:r>
            <a:r>
              <a:rPr lang="en-GB" altLang="nl-BE" sz="1200" dirty="0"/>
              <a:t>and the EPIC nutrient database (</a:t>
            </a:r>
            <a:r>
              <a:rPr lang="en-GB" altLang="nl-BE" sz="1200" dirty="0" smtClean="0"/>
              <a:t>ENDB). The </a:t>
            </a:r>
            <a:r>
              <a:rPr lang="en-GB" altLang="nl-BE" sz="1200" dirty="0"/>
              <a:t>mean difference is represented by the full line, upper and lower limit of agreement are presented by dotted lines.</a:t>
            </a:r>
          </a:p>
        </p:txBody>
      </p:sp>
      <p:sp>
        <p:nvSpPr>
          <p:cNvPr id="5" name="Tekstvak 4"/>
          <p:cNvSpPr txBox="1"/>
          <p:nvPr/>
        </p:nvSpPr>
        <p:spPr>
          <a:xfrm>
            <a:off x="3429000" y="5506700"/>
            <a:ext cx="559117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/>
              <a:t>mean phosphorus intake (mg/day): (USNDB mean + ENDB mean)/2</a:t>
            </a:r>
            <a:endParaRPr lang="en-GB" sz="1200" dirty="0"/>
          </a:p>
        </p:txBody>
      </p:sp>
      <p:sp>
        <p:nvSpPr>
          <p:cNvPr id="6" name="Tekstvak 5"/>
          <p:cNvSpPr txBox="1"/>
          <p:nvPr/>
        </p:nvSpPr>
        <p:spPr>
          <a:xfrm rot="16200000">
            <a:off x="984435" y="3457186"/>
            <a:ext cx="317182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m</a:t>
            </a:r>
            <a:r>
              <a:rPr lang="en-GB" sz="1200" dirty="0" smtClean="0"/>
              <a:t>ean difference in phosphorus intake (mg/day)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371743306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914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80149" y="1579327"/>
            <a:ext cx="6927242" cy="40781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8916" name="Tekstvak 3"/>
          <p:cNvSpPr txBox="1">
            <a:spLocks noChangeArrowheads="1"/>
          </p:cNvSpPr>
          <p:nvPr/>
        </p:nvSpPr>
        <p:spPr bwMode="auto">
          <a:xfrm>
            <a:off x="2033130" y="393049"/>
            <a:ext cx="8333463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nl-BE" sz="1200" b="1" dirty="0" smtClean="0"/>
              <a:t>Figures S2n</a:t>
            </a:r>
          </a:p>
          <a:p>
            <a:r>
              <a:rPr lang="en-GB" altLang="nl-BE" sz="1200" dirty="0" smtClean="0"/>
              <a:t>Bland-Altman plots for the </a:t>
            </a:r>
            <a:r>
              <a:rPr lang="en-GB" altLang="nl-BE" sz="1200" u="sng" dirty="0" smtClean="0"/>
              <a:t>dietary </a:t>
            </a:r>
            <a:r>
              <a:rPr lang="en-GB" altLang="nl-BE" sz="1200" u="sng" dirty="0"/>
              <a:t>questionnaire </a:t>
            </a:r>
            <a:r>
              <a:rPr lang="en-GB" altLang="nl-BE" sz="1200" dirty="0"/>
              <a:t>(DQ) data representing the mean differences and their limits of agreement for vitamin D intakes (µg/day) between the U.S. nutrient database </a:t>
            </a:r>
            <a:r>
              <a:rPr lang="en-GB" altLang="nl-BE" sz="1200" dirty="0" smtClean="0"/>
              <a:t>(USNDB) </a:t>
            </a:r>
            <a:r>
              <a:rPr lang="en-GB" altLang="nl-BE" sz="1200" dirty="0"/>
              <a:t>and the EPIC nutrient database (ENDB</a:t>
            </a:r>
            <a:r>
              <a:rPr lang="en-GB" altLang="nl-BE" sz="1200" dirty="0" smtClean="0"/>
              <a:t>). </a:t>
            </a:r>
            <a:r>
              <a:rPr lang="en-GB" altLang="nl-BE" sz="1200" dirty="0"/>
              <a:t>The mean difference is represented by the full line, upper and lower limit of agreement are presented by dotted lines.</a:t>
            </a:r>
          </a:p>
        </p:txBody>
      </p:sp>
      <p:sp>
        <p:nvSpPr>
          <p:cNvPr id="5" name="Tekstvak 4"/>
          <p:cNvSpPr txBox="1"/>
          <p:nvPr/>
        </p:nvSpPr>
        <p:spPr>
          <a:xfrm>
            <a:off x="3467100" y="5344775"/>
            <a:ext cx="559117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/>
              <a:t>mean vitamin D intake (mg/day): (USNDB mean + ENDB mean)/2</a:t>
            </a:r>
            <a:endParaRPr lang="en-GB" sz="1200" dirty="0"/>
          </a:p>
        </p:txBody>
      </p:sp>
      <p:sp>
        <p:nvSpPr>
          <p:cNvPr id="6" name="Tekstvak 5"/>
          <p:cNvSpPr txBox="1"/>
          <p:nvPr/>
        </p:nvSpPr>
        <p:spPr>
          <a:xfrm rot="16200000">
            <a:off x="1155885" y="3285738"/>
            <a:ext cx="309562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m</a:t>
            </a:r>
            <a:r>
              <a:rPr lang="en-GB" sz="1200" dirty="0" smtClean="0"/>
              <a:t>ean difference in vitamin D intake (µg/day)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198577013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938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81378" y="1335961"/>
            <a:ext cx="6927242" cy="44039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9939" name="Tekstvak 3"/>
          <p:cNvSpPr txBox="1">
            <a:spLocks noChangeArrowheads="1"/>
          </p:cNvSpPr>
          <p:nvPr/>
        </p:nvSpPr>
        <p:spPr bwMode="auto">
          <a:xfrm>
            <a:off x="2033131" y="393049"/>
            <a:ext cx="8333463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nl-BE" sz="1200" b="1" dirty="0" smtClean="0"/>
              <a:t>Figures S2o</a:t>
            </a:r>
          </a:p>
          <a:p>
            <a:r>
              <a:rPr lang="en-GB" altLang="nl-BE" sz="1200" dirty="0" smtClean="0"/>
              <a:t>Bland-Altman plots for the </a:t>
            </a:r>
            <a:r>
              <a:rPr lang="en-GB" altLang="nl-BE" sz="1200" u="sng" dirty="0" smtClean="0"/>
              <a:t>dietary </a:t>
            </a:r>
            <a:r>
              <a:rPr lang="en-GB" altLang="nl-BE" sz="1200" u="sng" dirty="0"/>
              <a:t>questionnaire </a:t>
            </a:r>
            <a:r>
              <a:rPr lang="en-GB" altLang="nl-BE" sz="1200" dirty="0"/>
              <a:t>(DQ) data representing the mean differences and their limits of agreement for vitamin E intakes (mg/day) between the U.S. nutrient database </a:t>
            </a:r>
            <a:r>
              <a:rPr lang="en-GB" altLang="nl-BE" sz="1200" dirty="0" smtClean="0"/>
              <a:t>(USNDB) </a:t>
            </a:r>
            <a:r>
              <a:rPr lang="en-GB" altLang="nl-BE" sz="1200" dirty="0"/>
              <a:t>and the EPIC nutrient database (</a:t>
            </a:r>
            <a:r>
              <a:rPr lang="en-GB" altLang="nl-BE" sz="1200" dirty="0" smtClean="0"/>
              <a:t>ENDB). </a:t>
            </a:r>
            <a:r>
              <a:rPr lang="en-GB" altLang="nl-BE" sz="1200" dirty="0"/>
              <a:t>The mean difference is represented by the full line, upper and lower limit of agreement are presented by dotted lines.</a:t>
            </a:r>
          </a:p>
        </p:txBody>
      </p:sp>
      <p:sp>
        <p:nvSpPr>
          <p:cNvPr id="5" name="Tekstvak 4"/>
          <p:cNvSpPr txBox="1"/>
          <p:nvPr/>
        </p:nvSpPr>
        <p:spPr>
          <a:xfrm>
            <a:off x="3400426" y="5420975"/>
            <a:ext cx="556260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/>
              <a:t>mean vitamin E intake (mg/day): (USNDB mean + ENDB mean)/2</a:t>
            </a:r>
            <a:endParaRPr lang="en-GB" sz="1200" dirty="0"/>
          </a:p>
        </p:txBody>
      </p:sp>
      <p:sp>
        <p:nvSpPr>
          <p:cNvPr id="6" name="Tekstvak 5"/>
          <p:cNvSpPr txBox="1"/>
          <p:nvPr/>
        </p:nvSpPr>
        <p:spPr>
          <a:xfrm rot="16200000">
            <a:off x="922520" y="3166674"/>
            <a:ext cx="333375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m</a:t>
            </a:r>
            <a:r>
              <a:rPr lang="en-GB" sz="1200" dirty="0" smtClean="0"/>
              <a:t>ean difference in vitamin E intake (mg/day)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382203258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6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27409" y="1542669"/>
            <a:ext cx="6927242" cy="40781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0963" name="Tekstvak 3"/>
          <p:cNvSpPr txBox="1">
            <a:spLocks noChangeArrowheads="1"/>
          </p:cNvSpPr>
          <p:nvPr/>
        </p:nvSpPr>
        <p:spPr bwMode="auto">
          <a:xfrm>
            <a:off x="2033131" y="393049"/>
            <a:ext cx="8333463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nl-BE" sz="1200" b="1" dirty="0" smtClean="0"/>
              <a:t>Figures S2p</a:t>
            </a:r>
          </a:p>
          <a:p>
            <a:r>
              <a:rPr lang="en-GB" altLang="nl-BE" sz="1200" dirty="0" smtClean="0"/>
              <a:t>Bland-Altman plots for the </a:t>
            </a:r>
            <a:r>
              <a:rPr lang="en-GB" altLang="nl-BE" sz="1200" u="sng" dirty="0" smtClean="0"/>
              <a:t>dietary </a:t>
            </a:r>
            <a:r>
              <a:rPr lang="en-GB" altLang="nl-BE" sz="1200" u="sng" dirty="0"/>
              <a:t>questionnaire </a:t>
            </a:r>
            <a:r>
              <a:rPr lang="en-GB" altLang="nl-BE" sz="1200" dirty="0"/>
              <a:t>(DQ) data representing the mean differences and their limits of agreement for </a:t>
            </a:r>
            <a:r>
              <a:rPr lang="en-GB" altLang="nl-BE" sz="1200" dirty="0" smtClean="0"/>
              <a:t>vitamin A (retinol) </a:t>
            </a:r>
            <a:r>
              <a:rPr lang="en-GB" altLang="nl-BE" sz="1200" dirty="0"/>
              <a:t>intakes (µg/day) between the U.S. nutrient database </a:t>
            </a:r>
            <a:r>
              <a:rPr lang="en-GB" altLang="nl-BE" sz="1200" dirty="0" smtClean="0"/>
              <a:t>(USNDB) </a:t>
            </a:r>
            <a:r>
              <a:rPr lang="en-GB" altLang="nl-BE" sz="1200" dirty="0"/>
              <a:t>and the EPIC nutrient database (ENDB</a:t>
            </a:r>
            <a:r>
              <a:rPr lang="en-GB" altLang="nl-BE" sz="1200" dirty="0" smtClean="0"/>
              <a:t>). </a:t>
            </a:r>
            <a:r>
              <a:rPr lang="en-GB" altLang="nl-BE" sz="1200" dirty="0"/>
              <a:t>The mean difference is represented by the full line, upper and lower limit of agreement are presented by dotted lines.</a:t>
            </a:r>
          </a:p>
        </p:txBody>
      </p:sp>
      <p:sp>
        <p:nvSpPr>
          <p:cNvPr id="5" name="Tekstvak 4"/>
          <p:cNvSpPr txBox="1"/>
          <p:nvPr/>
        </p:nvSpPr>
        <p:spPr>
          <a:xfrm>
            <a:off x="3409951" y="5316200"/>
            <a:ext cx="546735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/>
              <a:t>mean vitamin A (retinol) intake (µg/day): (USNDB mean + ENDB mean)/2</a:t>
            </a:r>
            <a:endParaRPr lang="en-GB" sz="1200" dirty="0"/>
          </a:p>
        </p:txBody>
      </p:sp>
      <p:sp>
        <p:nvSpPr>
          <p:cNvPr id="6" name="Tekstvak 5"/>
          <p:cNvSpPr txBox="1"/>
          <p:nvPr/>
        </p:nvSpPr>
        <p:spPr>
          <a:xfrm rot="16200000">
            <a:off x="903473" y="3064818"/>
            <a:ext cx="3219447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m</a:t>
            </a:r>
            <a:r>
              <a:rPr lang="en-GB" sz="1200" dirty="0" smtClean="0"/>
              <a:t>ean difference in vitamin A (retinol) intake (µg/day)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2946426057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986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89314" y="1335961"/>
            <a:ext cx="6927242" cy="40771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1987" name="Tekstvak 3"/>
          <p:cNvSpPr txBox="1">
            <a:spLocks noChangeArrowheads="1"/>
          </p:cNvSpPr>
          <p:nvPr/>
        </p:nvSpPr>
        <p:spPr bwMode="auto">
          <a:xfrm>
            <a:off x="2033131" y="393049"/>
            <a:ext cx="8333463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nl-BE" sz="1200" b="1" dirty="0" smtClean="0"/>
              <a:t>Figures S2q</a:t>
            </a:r>
          </a:p>
          <a:p>
            <a:r>
              <a:rPr lang="en-GB" altLang="nl-BE" sz="1200" dirty="0" smtClean="0"/>
              <a:t>Bland-Altman plots for the </a:t>
            </a:r>
            <a:r>
              <a:rPr lang="en-GB" altLang="nl-BE" sz="1200" u="sng" dirty="0" smtClean="0"/>
              <a:t>dietary </a:t>
            </a:r>
            <a:r>
              <a:rPr lang="en-GB" altLang="nl-BE" sz="1200" u="sng" dirty="0"/>
              <a:t>questionnaire </a:t>
            </a:r>
            <a:r>
              <a:rPr lang="en-GB" altLang="nl-BE" sz="1200" dirty="0"/>
              <a:t>(DQ) data representing the mean differences and their limits of agreement for beta-carotene intakes (µg/day) between the U.S. nutrient database </a:t>
            </a:r>
            <a:r>
              <a:rPr lang="en-GB" altLang="nl-BE" sz="1200" dirty="0" smtClean="0"/>
              <a:t>(USNDB) </a:t>
            </a:r>
            <a:r>
              <a:rPr lang="en-GB" altLang="nl-BE" sz="1200" dirty="0"/>
              <a:t>and the EPIC nutrient database (ENDB</a:t>
            </a:r>
            <a:r>
              <a:rPr lang="en-GB" altLang="nl-BE" sz="1200" dirty="0" smtClean="0"/>
              <a:t>). </a:t>
            </a:r>
            <a:r>
              <a:rPr lang="en-GB" altLang="nl-BE" sz="1200" dirty="0"/>
              <a:t>The mean difference is represented by the full line, upper and lower limit of agreement are presented by dotted lines.</a:t>
            </a:r>
          </a:p>
        </p:txBody>
      </p:sp>
      <p:sp>
        <p:nvSpPr>
          <p:cNvPr id="5" name="Tekstvak 4"/>
          <p:cNvSpPr txBox="1"/>
          <p:nvPr/>
        </p:nvSpPr>
        <p:spPr>
          <a:xfrm>
            <a:off x="3533775" y="5097125"/>
            <a:ext cx="559117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/>
              <a:t>mean beta-carotene intake (µg/day): (USNDB mean + ENDB mean)/2</a:t>
            </a:r>
            <a:endParaRPr lang="en-GB" sz="1200" dirty="0"/>
          </a:p>
        </p:txBody>
      </p:sp>
      <p:sp>
        <p:nvSpPr>
          <p:cNvPr id="6" name="Tekstvak 5"/>
          <p:cNvSpPr txBox="1"/>
          <p:nvPr/>
        </p:nvSpPr>
        <p:spPr>
          <a:xfrm rot="16200000">
            <a:off x="1089208" y="2936229"/>
            <a:ext cx="3190877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m</a:t>
            </a:r>
            <a:r>
              <a:rPr lang="en-GB" sz="1200" dirty="0" smtClean="0"/>
              <a:t>ean difference in beta-carotene intake (µg/day)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710816545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010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90542" y="1507029"/>
            <a:ext cx="6927242" cy="40781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3011" name="Tekstvak 3"/>
          <p:cNvSpPr txBox="1">
            <a:spLocks noChangeArrowheads="1"/>
          </p:cNvSpPr>
          <p:nvPr/>
        </p:nvSpPr>
        <p:spPr bwMode="auto">
          <a:xfrm>
            <a:off x="2033131" y="393049"/>
            <a:ext cx="8333463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nl-BE" sz="1200" b="1" dirty="0" smtClean="0"/>
              <a:t>Figures S2r</a:t>
            </a:r>
          </a:p>
          <a:p>
            <a:r>
              <a:rPr lang="en-GB" altLang="nl-BE" sz="1200" dirty="0" smtClean="0"/>
              <a:t>Bland-Altman plots for the </a:t>
            </a:r>
            <a:r>
              <a:rPr lang="en-GB" altLang="nl-BE" sz="1200" u="sng" dirty="0" smtClean="0"/>
              <a:t>dietary </a:t>
            </a:r>
            <a:r>
              <a:rPr lang="en-GB" altLang="nl-BE" sz="1200" u="sng" dirty="0"/>
              <a:t>questionnaire </a:t>
            </a:r>
            <a:r>
              <a:rPr lang="en-GB" altLang="nl-BE" sz="1200" dirty="0"/>
              <a:t>(DQ) data representing the mean differences and their limits of agreement for vitamin B1 (</a:t>
            </a:r>
            <a:r>
              <a:rPr lang="en-GB" altLang="nl-BE" sz="1200" dirty="0" smtClean="0"/>
              <a:t>thiamine) </a:t>
            </a:r>
            <a:r>
              <a:rPr lang="en-GB" altLang="nl-BE" sz="1200" dirty="0"/>
              <a:t>intakes (mg/day) between the U.S. nutrient database </a:t>
            </a:r>
            <a:r>
              <a:rPr lang="en-GB" altLang="nl-BE" sz="1200" dirty="0" smtClean="0"/>
              <a:t>(USNDB) </a:t>
            </a:r>
            <a:r>
              <a:rPr lang="en-GB" altLang="nl-BE" sz="1200" dirty="0"/>
              <a:t>and the EPIC nutrient database (ENDB</a:t>
            </a:r>
            <a:r>
              <a:rPr lang="en-GB" altLang="nl-BE" sz="1200" dirty="0" smtClean="0"/>
              <a:t>). </a:t>
            </a:r>
            <a:r>
              <a:rPr lang="en-GB" altLang="nl-BE" sz="1200" dirty="0"/>
              <a:t>The mean difference is represented by the full line, upper and lower limit of agreement are presented by dotted lines.</a:t>
            </a:r>
          </a:p>
        </p:txBody>
      </p:sp>
      <p:sp>
        <p:nvSpPr>
          <p:cNvPr id="5" name="Tekstvak 4"/>
          <p:cNvSpPr txBox="1"/>
          <p:nvPr/>
        </p:nvSpPr>
        <p:spPr>
          <a:xfrm>
            <a:off x="3333750" y="5259050"/>
            <a:ext cx="559117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/>
              <a:t>mean vitamin B1 (thiamine) intake (mg/day): (USNDB mean + ENDB mean)/2</a:t>
            </a:r>
            <a:endParaRPr lang="en-GB" sz="1200" dirty="0"/>
          </a:p>
        </p:txBody>
      </p:sp>
      <p:sp>
        <p:nvSpPr>
          <p:cNvPr id="6" name="Tekstvak 5"/>
          <p:cNvSpPr txBox="1"/>
          <p:nvPr/>
        </p:nvSpPr>
        <p:spPr>
          <a:xfrm rot="16200000">
            <a:off x="951098" y="3036242"/>
            <a:ext cx="3295650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m</a:t>
            </a:r>
            <a:r>
              <a:rPr lang="en-GB" sz="1200" dirty="0" smtClean="0"/>
              <a:t>ean difference in vitamin B1 (thiamine) intake (mg/day)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285850275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034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07642" y="1633294"/>
            <a:ext cx="6927242" cy="40781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4035" name="Tekstvak 3"/>
          <p:cNvSpPr txBox="1">
            <a:spLocks noChangeArrowheads="1"/>
          </p:cNvSpPr>
          <p:nvPr/>
        </p:nvSpPr>
        <p:spPr bwMode="auto">
          <a:xfrm>
            <a:off x="2033131" y="393049"/>
            <a:ext cx="8333463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nl-BE" sz="1200" b="1" dirty="0" smtClean="0"/>
              <a:t>Figures S2s</a:t>
            </a:r>
          </a:p>
          <a:p>
            <a:r>
              <a:rPr lang="en-GB" altLang="nl-BE" sz="1200" dirty="0" smtClean="0"/>
              <a:t>Bland-Altman plots for the </a:t>
            </a:r>
            <a:r>
              <a:rPr lang="en-GB" altLang="nl-BE" sz="1200" u="sng" dirty="0" smtClean="0"/>
              <a:t>dietary </a:t>
            </a:r>
            <a:r>
              <a:rPr lang="en-GB" altLang="nl-BE" sz="1200" u="sng" dirty="0"/>
              <a:t>questionnaire </a:t>
            </a:r>
            <a:r>
              <a:rPr lang="en-GB" altLang="nl-BE" sz="1200" dirty="0"/>
              <a:t>(DQ) data representing the mean differences and their limits of agreement for vitamin B2 (</a:t>
            </a:r>
            <a:r>
              <a:rPr lang="en-GB" altLang="nl-BE" sz="1200" dirty="0" smtClean="0"/>
              <a:t>riboflavin) </a:t>
            </a:r>
            <a:r>
              <a:rPr lang="en-GB" altLang="nl-BE" sz="1200" dirty="0"/>
              <a:t>intakes (mg/day) between the U.S. nutrient database </a:t>
            </a:r>
            <a:r>
              <a:rPr lang="en-GB" altLang="nl-BE" sz="1200" dirty="0" smtClean="0"/>
              <a:t>(USNDB) </a:t>
            </a:r>
            <a:r>
              <a:rPr lang="en-GB" altLang="nl-BE" sz="1200" dirty="0"/>
              <a:t>and the EPIC nutrient database (ENDB</a:t>
            </a:r>
            <a:r>
              <a:rPr lang="en-GB" altLang="nl-BE" sz="1200" dirty="0" smtClean="0"/>
              <a:t>). </a:t>
            </a:r>
            <a:r>
              <a:rPr lang="en-GB" altLang="nl-BE" sz="1200" dirty="0"/>
              <a:t>The mean difference is represented by the full line, upper and lower limit of agreement are presented by dotted lines.</a:t>
            </a:r>
          </a:p>
        </p:txBody>
      </p:sp>
      <p:sp>
        <p:nvSpPr>
          <p:cNvPr id="5" name="Tekstvak 4"/>
          <p:cNvSpPr txBox="1"/>
          <p:nvPr/>
        </p:nvSpPr>
        <p:spPr>
          <a:xfrm>
            <a:off x="3438525" y="5373350"/>
            <a:ext cx="561975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/>
              <a:t>mean vitamin B2 (riboflavin) intake (mg/day): (USNDB mean + ENDB mean)/2</a:t>
            </a:r>
            <a:endParaRPr lang="en-GB" sz="1200" dirty="0"/>
          </a:p>
        </p:txBody>
      </p:sp>
      <p:sp>
        <p:nvSpPr>
          <p:cNvPr id="6" name="Tekstvak 5"/>
          <p:cNvSpPr txBox="1"/>
          <p:nvPr/>
        </p:nvSpPr>
        <p:spPr>
          <a:xfrm rot="16200000">
            <a:off x="960621" y="3074341"/>
            <a:ext cx="3467102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m</a:t>
            </a:r>
            <a:r>
              <a:rPr lang="en-GB" sz="1200" dirty="0" smtClean="0"/>
              <a:t>ean difference in vitamin B2 (riboflavin) intake (mg/day)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10245943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626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15368" y="1470372"/>
            <a:ext cx="6927242" cy="40781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6627" name="Tekstvak 5"/>
          <p:cNvSpPr txBox="1">
            <a:spLocks noChangeArrowheads="1"/>
          </p:cNvSpPr>
          <p:nvPr/>
        </p:nvSpPr>
        <p:spPr bwMode="auto">
          <a:xfrm>
            <a:off x="2033131" y="393049"/>
            <a:ext cx="8333463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nl-BE" sz="1200" b="1" dirty="0" smtClean="0"/>
              <a:t>Figures S2b</a:t>
            </a:r>
          </a:p>
          <a:p>
            <a:r>
              <a:rPr lang="en-GB" altLang="nl-BE" sz="1200" dirty="0" smtClean="0"/>
              <a:t>Bland-Altman plots for the </a:t>
            </a:r>
            <a:r>
              <a:rPr lang="en-GB" altLang="nl-BE" sz="1200" u="sng" dirty="0" smtClean="0"/>
              <a:t>dietary </a:t>
            </a:r>
            <a:r>
              <a:rPr lang="en-GB" altLang="nl-BE" sz="1200" u="sng" dirty="0"/>
              <a:t>questionnaire </a:t>
            </a:r>
            <a:r>
              <a:rPr lang="en-GB" altLang="nl-BE" sz="1200" dirty="0"/>
              <a:t>(DQ) data representing the mean differences and their limits of agreement for total fatty acids intakes (g/day) between the U.S. nutrient database </a:t>
            </a:r>
            <a:r>
              <a:rPr lang="en-GB" altLang="nl-BE" sz="1200" dirty="0" smtClean="0"/>
              <a:t>(USNDB) and </a:t>
            </a:r>
            <a:r>
              <a:rPr lang="en-GB" altLang="nl-BE" sz="1200" dirty="0"/>
              <a:t>the EPIC nutrient database (</a:t>
            </a:r>
            <a:r>
              <a:rPr lang="en-GB" altLang="nl-BE" sz="1200" dirty="0" smtClean="0"/>
              <a:t>ENDB). </a:t>
            </a:r>
            <a:r>
              <a:rPr lang="en-GB" altLang="nl-BE" sz="1200" dirty="0"/>
              <a:t>The mean difference is represented by the full line, upper and lower limit of agreement are presented by dotted lines.</a:t>
            </a:r>
          </a:p>
        </p:txBody>
      </p:sp>
      <p:sp>
        <p:nvSpPr>
          <p:cNvPr id="4" name="Tekstvak 3"/>
          <p:cNvSpPr txBox="1"/>
          <p:nvPr/>
        </p:nvSpPr>
        <p:spPr>
          <a:xfrm>
            <a:off x="3686175" y="5240000"/>
            <a:ext cx="557859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/>
              <a:t>mean </a:t>
            </a:r>
            <a:r>
              <a:rPr lang="en-GB" altLang="nl-BE" sz="1200" dirty="0"/>
              <a:t>total saturated fatty acid </a:t>
            </a:r>
            <a:r>
              <a:rPr lang="en-GB" sz="1200" dirty="0" smtClean="0"/>
              <a:t>intake (g/day): (USNDB mean + ENDB mean)/2</a:t>
            </a:r>
            <a:endParaRPr lang="en-GB" sz="1200" dirty="0"/>
          </a:p>
        </p:txBody>
      </p:sp>
      <p:sp>
        <p:nvSpPr>
          <p:cNvPr id="5" name="Tekstvak 4"/>
          <p:cNvSpPr txBox="1"/>
          <p:nvPr/>
        </p:nvSpPr>
        <p:spPr>
          <a:xfrm rot="16200000">
            <a:off x="1284471" y="3138099"/>
            <a:ext cx="323849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m</a:t>
            </a:r>
            <a:r>
              <a:rPr lang="en-GB" sz="1200" dirty="0" smtClean="0"/>
              <a:t>ean difference in folate intake (µg/day)</a:t>
            </a:r>
            <a:endParaRPr lang="en-GB" sz="1200" dirty="0"/>
          </a:p>
        </p:txBody>
      </p:sp>
      <p:sp>
        <p:nvSpPr>
          <p:cNvPr id="6" name="Tekstvak 5"/>
          <p:cNvSpPr txBox="1"/>
          <p:nvPr/>
        </p:nvSpPr>
        <p:spPr>
          <a:xfrm rot="16200000">
            <a:off x="1255895" y="3007666"/>
            <a:ext cx="3333752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m</a:t>
            </a:r>
            <a:r>
              <a:rPr lang="en-GB" sz="1200" dirty="0" smtClean="0"/>
              <a:t>ean difference in </a:t>
            </a:r>
            <a:r>
              <a:rPr lang="en-GB" altLang="nl-BE" sz="1200" dirty="0"/>
              <a:t>total saturated fatty acid </a:t>
            </a:r>
            <a:r>
              <a:rPr lang="en-GB" sz="1200" dirty="0" smtClean="0"/>
              <a:t>intake (g/day)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275056591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058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70984" y="1434733"/>
            <a:ext cx="6928260" cy="40781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5059" name="Tekstvak 3"/>
          <p:cNvSpPr txBox="1">
            <a:spLocks noChangeArrowheads="1"/>
          </p:cNvSpPr>
          <p:nvPr/>
        </p:nvSpPr>
        <p:spPr bwMode="auto">
          <a:xfrm>
            <a:off x="2033131" y="393049"/>
            <a:ext cx="8333463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nl-BE" sz="1200" b="1" dirty="0" smtClean="0"/>
              <a:t>Figures S2t</a:t>
            </a:r>
          </a:p>
          <a:p>
            <a:r>
              <a:rPr lang="en-GB" altLang="nl-BE" sz="1200" dirty="0" smtClean="0"/>
              <a:t>Bland-Altman plots for the </a:t>
            </a:r>
            <a:r>
              <a:rPr lang="en-GB" altLang="nl-BE" sz="1200" u="sng" dirty="0" smtClean="0"/>
              <a:t>dietary </a:t>
            </a:r>
            <a:r>
              <a:rPr lang="en-GB" altLang="nl-BE" sz="1200" u="sng" dirty="0"/>
              <a:t>questionnaire </a:t>
            </a:r>
            <a:r>
              <a:rPr lang="en-GB" altLang="nl-BE" sz="1200" dirty="0"/>
              <a:t>(DQ) data representing the mean differences and their limits of agreement for vitamin B12 </a:t>
            </a:r>
            <a:r>
              <a:rPr lang="en-GB" altLang="nl-BE" sz="1200" dirty="0" smtClean="0"/>
              <a:t>(cobalamin) intakes </a:t>
            </a:r>
            <a:r>
              <a:rPr lang="en-GB" altLang="nl-BE" sz="1200" dirty="0"/>
              <a:t>(µg/day) between the U.S. nutrient database </a:t>
            </a:r>
            <a:r>
              <a:rPr lang="en-GB" altLang="nl-BE" sz="1200" dirty="0" smtClean="0"/>
              <a:t>(USNDB) </a:t>
            </a:r>
            <a:r>
              <a:rPr lang="en-GB" altLang="nl-BE" sz="1200" dirty="0"/>
              <a:t>and the EPIC nutrient database (ENDB</a:t>
            </a:r>
            <a:r>
              <a:rPr lang="en-GB" altLang="nl-BE" sz="1200" dirty="0" smtClean="0"/>
              <a:t>). </a:t>
            </a:r>
            <a:r>
              <a:rPr lang="en-GB" altLang="nl-BE" sz="1200" dirty="0"/>
              <a:t>The mean difference is represented by the full line, upper and lower limit of agreement are presented by dotted lines.</a:t>
            </a:r>
          </a:p>
        </p:txBody>
      </p:sp>
      <p:sp>
        <p:nvSpPr>
          <p:cNvPr id="5" name="Tekstvak 4"/>
          <p:cNvSpPr txBox="1"/>
          <p:nvPr/>
        </p:nvSpPr>
        <p:spPr>
          <a:xfrm>
            <a:off x="3467100" y="5192375"/>
            <a:ext cx="562927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/>
              <a:t>mean vitamin B12 (cobalamin) intake (µg/day): (USNDB mean + ENDB mean)/2</a:t>
            </a:r>
            <a:endParaRPr lang="en-GB" sz="1200" dirty="0"/>
          </a:p>
        </p:txBody>
      </p:sp>
      <p:sp>
        <p:nvSpPr>
          <p:cNvPr id="6" name="Tekstvak 5"/>
          <p:cNvSpPr txBox="1"/>
          <p:nvPr/>
        </p:nvSpPr>
        <p:spPr>
          <a:xfrm rot="16200000">
            <a:off x="1013007" y="2983855"/>
            <a:ext cx="3286130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m</a:t>
            </a:r>
            <a:r>
              <a:rPr lang="en-GB" sz="1200" dirty="0" smtClean="0"/>
              <a:t>ean difference in vitamin B12 (cobalamin) intake (µg/day)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2558037216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08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17017" y="1542669"/>
            <a:ext cx="6927242" cy="40781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6083" name="Tekstvak 3"/>
          <p:cNvSpPr txBox="1">
            <a:spLocks noChangeArrowheads="1"/>
          </p:cNvSpPr>
          <p:nvPr/>
        </p:nvSpPr>
        <p:spPr bwMode="auto">
          <a:xfrm>
            <a:off x="2033131" y="393049"/>
            <a:ext cx="8333463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nl-BE" sz="1200" b="1" dirty="0" smtClean="0"/>
              <a:t>Figures S2u</a:t>
            </a:r>
          </a:p>
          <a:p>
            <a:r>
              <a:rPr lang="en-GB" altLang="nl-BE" sz="1200" dirty="0" smtClean="0"/>
              <a:t>Bland-Altman plots for the </a:t>
            </a:r>
            <a:r>
              <a:rPr lang="en-GB" altLang="nl-BE" sz="1200" u="sng" dirty="0" smtClean="0"/>
              <a:t>dietary </a:t>
            </a:r>
            <a:r>
              <a:rPr lang="en-GB" altLang="nl-BE" sz="1200" u="sng" dirty="0"/>
              <a:t>questionnaire </a:t>
            </a:r>
            <a:r>
              <a:rPr lang="en-GB" altLang="nl-BE" sz="1200" dirty="0"/>
              <a:t>(DQ) data representing the mean differences and their limits of agreement for vitamin B6 intakes (mg/day) between the U.S. nutrient database </a:t>
            </a:r>
            <a:r>
              <a:rPr lang="en-GB" altLang="nl-BE" sz="1200" dirty="0" smtClean="0"/>
              <a:t>(USNDB) </a:t>
            </a:r>
            <a:r>
              <a:rPr lang="en-GB" altLang="nl-BE" sz="1200" dirty="0"/>
              <a:t>and the EPIC nutrient database (ENDB</a:t>
            </a:r>
            <a:r>
              <a:rPr lang="en-GB" altLang="nl-BE" sz="1200" dirty="0" smtClean="0"/>
              <a:t>). </a:t>
            </a:r>
            <a:r>
              <a:rPr lang="en-GB" altLang="nl-BE" sz="1200" dirty="0"/>
              <a:t>The mean difference is represented by the full line, upper and lower limit of agreement are presented by dotted lines.</a:t>
            </a:r>
          </a:p>
        </p:txBody>
      </p:sp>
      <p:sp>
        <p:nvSpPr>
          <p:cNvPr id="5" name="Tekstvak 4"/>
          <p:cNvSpPr txBox="1"/>
          <p:nvPr/>
        </p:nvSpPr>
        <p:spPr>
          <a:xfrm>
            <a:off x="3409950" y="5287625"/>
            <a:ext cx="560070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/>
              <a:t>mean vitamin B6 intake (mg/day): (USNDB mean + ENDB mean)/2</a:t>
            </a:r>
            <a:endParaRPr lang="en-GB" sz="1200" dirty="0"/>
          </a:p>
        </p:txBody>
      </p:sp>
      <p:sp>
        <p:nvSpPr>
          <p:cNvPr id="6" name="Tekstvak 5"/>
          <p:cNvSpPr txBox="1"/>
          <p:nvPr/>
        </p:nvSpPr>
        <p:spPr>
          <a:xfrm rot="16200000">
            <a:off x="989194" y="3204776"/>
            <a:ext cx="323850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m</a:t>
            </a:r>
            <a:r>
              <a:rPr lang="en-GB" sz="1200" dirty="0" smtClean="0"/>
              <a:t>ean difference in vitamin B6 intake (mg/day)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470908251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106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34117" y="1542669"/>
            <a:ext cx="6928260" cy="40781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7107" name="Tekstvak 3"/>
          <p:cNvSpPr txBox="1">
            <a:spLocks noChangeArrowheads="1"/>
          </p:cNvSpPr>
          <p:nvPr/>
        </p:nvSpPr>
        <p:spPr bwMode="auto">
          <a:xfrm>
            <a:off x="2033131" y="393049"/>
            <a:ext cx="8333463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nl-BE" sz="1200" b="1" dirty="0" smtClean="0"/>
              <a:t>Figures S2v</a:t>
            </a:r>
          </a:p>
          <a:p>
            <a:r>
              <a:rPr lang="en-GB" altLang="nl-BE" sz="1200" dirty="0" smtClean="0"/>
              <a:t>Bland-Altman plots for the </a:t>
            </a:r>
            <a:r>
              <a:rPr lang="en-GB" altLang="nl-BE" sz="1200" u="sng" dirty="0" smtClean="0"/>
              <a:t>dietary </a:t>
            </a:r>
            <a:r>
              <a:rPr lang="en-GB" altLang="nl-BE" sz="1200" u="sng" dirty="0"/>
              <a:t>questionnaire </a:t>
            </a:r>
            <a:r>
              <a:rPr lang="en-GB" altLang="nl-BE" sz="1200" dirty="0"/>
              <a:t>(DQ) data representing the mean differences and their limits of agreement for vitamin C intakes (mg/day) between the U.S. nutrient database </a:t>
            </a:r>
            <a:r>
              <a:rPr lang="en-GB" altLang="nl-BE" sz="1200" dirty="0" smtClean="0"/>
              <a:t>(USNDB) </a:t>
            </a:r>
            <a:r>
              <a:rPr lang="en-GB" altLang="nl-BE" sz="1200" dirty="0"/>
              <a:t>and the EPIC nutrient database (ENDB</a:t>
            </a:r>
            <a:r>
              <a:rPr lang="en-GB" altLang="nl-BE" sz="1200" dirty="0" smtClean="0"/>
              <a:t>). </a:t>
            </a:r>
            <a:r>
              <a:rPr lang="en-GB" altLang="nl-BE" sz="1200" dirty="0"/>
              <a:t>The mean difference is represented by the full line, upper and lower limit of agreement are presented by dotted lines.</a:t>
            </a:r>
          </a:p>
        </p:txBody>
      </p:sp>
      <p:sp>
        <p:nvSpPr>
          <p:cNvPr id="5" name="Tekstvak 4"/>
          <p:cNvSpPr txBox="1"/>
          <p:nvPr/>
        </p:nvSpPr>
        <p:spPr>
          <a:xfrm>
            <a:off x="3562350" y="5287625"/>
            <a:ext cx="560070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/>
              <a:t>mean vitamin C intake (mg/day): (USNDB mean + ENDB mean)/2</a:t>
            </a:r>
            <a:endParaRPr lang="en-GB" sz="1200" dirty="0"/>
          </a:p>
        </p:txBody>
      </p:sp>
      <p:sp>
        <p:nvSpPr>
          <p:cNvPr id="6" name="Tekstvak 5"/>
          <p:cNvSpPr txBox="1"/>
          <p:nvPr/>
        </p:nvSpPr>
        <p:spPr>
          <a:xfrm rot="16200000">
            <a:off x="1079684" y="3190487"/>
            <a:ext cx="332422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m</a:t>
            </a:r>
            <a:r>
              <a:rPr lang="en-GB" sz="1200" dirty="0" smtClean="0"/>
              <a:t>ean difference in vitamin C intake (mg/day)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2514731743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130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70984" y="1588490"/>
            <a:ext cx="6928260" cy="40781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8131" name="Tekstvak 3"/>
          <p:cNvSpPr txBox="1">
            <a:spLocks noChangeArrowheads="1"/>
          </p:cNvSpPr>
          <p:nvPr/>
        </p:nvSpPr>
        <p:spPr bwMode="auto">
          <a:xfrm>
            <a:off x="2033131" y="393049"/>
            <a:ext cx="8333463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nl-BE" sz="1200" b="1" dirty="0" smtClean="0"/>
              <a:t>Figures S2w</a:t>
            </a:r>
          </a:p>
          <a:p>
            <a:r>
              <a:rPr lang="en-GB" altLang="nl-BE" sz="1200" dirty="0" smtClean="0"/>
              <a:t>Bland-Altman plots for the </a:t>
            </a:r>
            <a:r>
              <a:rPr lang="en-GB" altLang="nl-BE" sz="1200" u="sng" dirty="0" smtClean="0"/>
              <a:t>dietary </a:t>
            </a:r>
            <a:r>
              <a:rPr lang="en-GB" altLang="nl-BE" sz="1200" u="sng" dirty="0"/>
              <a:t>questionnaire </a:t>
            </a:r>
            <a:r>
              <a:rPr lang="en-GB" altLang="nl-BE" sz="1200" dirty="0"/>
              <a:t>(DQ) data representing the mean differences and their limits of agreement for folate intakes (µg/day) between the U.S. nutrient database </a:t>
            </a:r>
            <a:r>
              <a:rPr lang="en-GB" altLang="nl-BE" sz="1200" dirty="0" smtClean="0"/>
              <a:t>(USNDB) </a:t>
            </a:r>
            <a:r>
              <a:rPr lang="en-GB" altLang="nl-BE" sz="1200" dirty="0"/>
              <a:t>and the EPIC nutrient database (ENDB</a:t>
            </a:r>
            <a:r>
              <a:rPr lang="en-GB" altLang="nl-BE" sz="1200" dirty="0" smtClean="0"/>
              <a:t>). </a:t>
            </a:r>
            <a:r>
              <a:rPr lang="en-GB" altLang="nl-BE" sz="1200" dirty="0"/>
              <a:t>The mean difference is represented by the full line, upper and lower limit of agreement are presented by dotted lines.</a:t>
            </a:r>
          </a:p>
        </p:txBody>
      </p:sp>
      <p:sp>
        <p:nvSpPr>
          <p:cNvPr id="5" name="Tekstvak 4"/>
          <p:cNvSpPr txBox="1"/>
          <p:nvPr/>
        </p:nvSpPr>
        <p:spPr>
          <a:xfrm>
            <a:off x="3533775" y="5335250"/>
            <a:ext cx="557212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/>
              <a:t>mean folate intake (µg/day): (USNDB mean + ENDB mean)/2</a:t>
            </a:r>
            <a:endParaRPr lang="en-GB" sz="1200" dirty="0"/>
          </a:p>
        </p:txBody>
      </p:sp>
      <p:sp>
        <p:nvSpPr>
          <p:cNvPr id="6" name="Tekstvak 5"/>
          <p:cNvSpPr txBox="1"/>
          <p:nvPr/>
        </p:nvSpPr>
        <p:spPr>
          <a:xfrm rot="16200000">
            <a:off x="1108263" y="3266689"/>
            <a:ext cx="311467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m</a:t>
            </a:r>
            <a:r>
              <a:rPr lang="en-GB" sz="1200" dirty="0" smtClean="0"/>
              <a:t>ean difference in folate intake (µg/day)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39916751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650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52446" y="1551833"/>
            <a:ext cx="6927242" cy="40781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7651" name="Tekstvak 3"/>
          <p:cNvSpPr txBox="1">
            <a:spLocks noChangeArrowheads="1"/>
          </p:cNvSpPr>
          <p:nvPr/>
        </p:nvSpPr>
        <p:spPr bwMode="auto">
          <a:xfrm>
            <a:off x="2033131" y="393049"/>
            <a:ext cx="8333463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nl-BE" sz="1200" b="1" dirty="0" smtClean="0"/>
              <a:t>Figures S2c</a:t>
            </a:r>
          </a:p>
          <a:p>
            <a:r>
              <a:rPr lang="en-GB" altLang="nl-BE" sz="1200" dirty="0" smtClean="0"/>
              <a:t>Bland-Altman plots for the </a:t>
            </a:r>
            <a:r>
              <a:rPr lang="en-GB" altLang="nl-BE" sz="1200" u="sng" dirty="0" smtClean="0"/>
              <a:t>dietary </a:t>
            </a:r>
            <a:r>
              <a:rPr lang="en-GB" altLang="nl-BE" sz="1200" u="sng" dirty="0"/>
              <a:t>questionnaire </a:t>
            </a:r>
            <a:r>
              <a:rPr lang="en-GB" altLang="nl-BE" sz="1200" dirty="0"/>
              <a:t>(DQ) data representing the mean differences and their limits of agreement for monounsaturated fatty acids intakes (g/day) between the U.S. nutrient database </a:t>
            </a:r>
            <a:r>
              <a:rPr lang="en-GB" altLang="nl-BE" sz="1200" dirty="0" smtClean="0"/>
              <a:t>(USNDB) and </a:t>
            </a:r>
            <a:r>
              <a:rPr lang="en-GB" altLang="nl-BE" sz="1200" dirty="0"/>
              <a:t>the EPIC nutrient database (</a:t>
            </a:r>
            <a:r>
              <a:rPr lang="en-GB" altLang="nl-BE" sz="1200" dirty="0" smtClean="0"/>
              <a:t>ENDB). The </a:t>
            </a:r>
            <a:r>
              <a:rPr lang="en-GB" altLang="nl-BE" sz="1200" dirty="0"/>
              <a:t>mean difference is represented by the full line, upper and lower limit of agreement are presented by dotted lines.</a:t>
            </a:r>
          </a:p>
        </p:txBody>
      </p:sp>
      <p:sp>
        <p:nvSpPr>
          <p:cNvPr id="5" name="Tekstvak 4"/>
          <p:cNvSpPr txBox="1"/>
          <p:nvPr/>
        </p:nvSpPr>
        <p:spPr>
          <a:xfrm>
            <a:off x="3550129" y="5325725"/>
            <a:ext cx="558129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/>
              <a:t>mean folate intake (µg/day): (USNDB mean + ENDB mean)/2</a:t>
            </a:r>
            <a:endParaRPr lang="en-GB" sz="1200" dirty="0"/>
          </a:p>
        </p:txBody>
      </p:sp>
      <p:sp>
        <p:nvSpPr>
          <p:cNvPr id="6" name="Tekstvak 5"/>
          <p:cNvSpPr txBox="1"/>
          <p:nvPr/>
        </p:nvSpPr>
        <p:spPr>
          <a:xfrm>
            <a:off x="3533775" y="5297150"/>
            <a:ext cx="557859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/>
              <a:t>mean </a:t>
            </a:r>
            <a:r>
              <a:rPr lang="en-GB" altLang="nl-BE" sz="1200" dirty="0" smtClean="0"/>
              <a:t>total </a:t>
            </a:r>
            <a:r>
              <a:rPr lang="en-GB" altLang="nl-BE" sz="1200" dirty="0"/>
              <a:t>monounsaturated </a:t>
            </a:r>
            <a:r>
              <a:rPr lang="en-GB" altLang="nl-BE" sz="1200" dirty="0" smtClean="0"/>
              <a:t>fatty acid </a:t>
            </a:r>
            <a:r>
              <a:rPr lang="en-GB" sz="1200" dirty="0" smtClean="0"/>
              <a:t>intake (g/day): (USNDB mean + ENDB mean)/2</a:t>
            </a:r>
            <a:endParaRPr lang="en-GB" sz="1200" dirty="0"/>
          </a:p>
        </p:txBody>
      </p:sp>
      <p:sp>
        <p:nvSpPr>
          <p:cNvPr id="7" name="Tekstvak 6"/>
          <p:cNvSpPr txBox="1"/>
          <p:nvPr/>
        </p:nvSpPr>
        <p:spPr>
          <a:xfrm rot="16200000">
            <a:off x="1055870" y="3112441"/>
            <a:ext cx="3333752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m</a:t>
            </a:r>
            <a:r>
              <a:rPr lang="en-GB" sz="1200" dirty="0" smtClean="0"/>
              <a:t>ean difference in </a:t>
            </a:r>
            <a:r>
              <a:rPr lang="en-GB" sz="1200" dirty="0"/>
              <a:t>mean </a:t>
            </a:r>
            <a:r>
              <a:rPr lang="en-GB" altLang="nl-BE" sz="1200" dirty="0"/>
              <a:t>total monounsaturated fatty acid</a:t>
            </a:r>
            <a:r>
              <a:rPr lang="en-GB" sz="1200" dirty="0" smtClean="0"/>
              <a:t> intake (g/day)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168461197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674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70984" y="1497865"/>
            <a:ext cx="6928260" cy="40781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8675" name="Tekstvak 3"/>
          <p:cNvSpPr txBox="1">
            <a:spLocks noChangeArrowheads="1"/>
          </p:cNvSpPr>
          <p:nvPr/>
        </p:nvSpPr>
        <p:spPr bwMode="auto">
          <a:xfrm>
            <a:off x="2033131" y="393049"/>
            <a:ext cx="8333463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nl-BE" sz="1200" b="1" dirty="0" smtClean="0"/>
              <a:t>Figures S2d</a:t>
            </a:r>
          </a:p>
          <a:p>
            <a:r>
              <a:rPr lang="en-GB" altLang="nl-BE" sz="1200" dirty="0" smtClean="0"/>
              <a:t>Bland-Altman plots for the </a:t>
            </a:r>
            <a:r>
              <a:rPr lang="en-GB" altLang="nl-BE" sz="1200" u="sng" dirty="0" smtClean="0"/>
              <a:t>dietary </a:t>
            </a:r>
            <a:r>
              <a:rPr lang="en-GB" altLang="nl-BE" sz="1200" u="sng" dirty="0"/>
              <a:t>questionnaire </a:t>
            </a:r>
            <a:r>
              <a:rPr lang="en-GB" altLang="nl-BE" sz="1200" dirty="0"/>
              <a:t>(DQ) data representing the mean differences and their limits of agreement for polyunsaturated fatty acids intakes (g/day) between the U.S. nutrient database </a:t>
            </a:r>
            <a:r>
              <a:rPr lang="en-GB" altLang="nl-BE" sz="1200" dirty="0" smtClean="0"/>
              <a:t>(USNDB) and </a:t>
            </a:r>
            <a:r>
              <a:rPr lang="en-GB" altLang="nl-BE" sz="1200" dirty="0"/>
              <a:t>the EPIC nutrient database (ENDB</a:t>
            </a:r>
            <a:r>
              <a:rPr lang="en-GB" altLang="nl-BE" sz="1200" dirty="0" smtClean="0"/>
              <a:t>). </a:t>
            </a:r>
            <a:r>
              <a:rPr lang="en-GB" altLang="nl-BE" sz="1200" dirty="0"/>
              <a:t>The mean difference is represented by the full line, upper and lower limit of agreement are presented by dotted lines.</a:t>
            </a:r>
          </a:p>
        </p:txBody>
      </p:sp>
      <p:sp>
        <p:nvSpPr>
          <p:cNvPr id="5" name="Tekstvak 4"/>
          <p:cNvSpPr txBox="1"/>
          <p:nvPr/>
        </p:nvSpPr>
        <p:spPr>
          <a:xfrm>
            <a:off x="3683479" y="5249525"/>
            <a:ext cx="558129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/>
              <a:t>mean folate intake (g/day): (USNDB mean + ENDB mean)/2</a:t>
            </a:r>
            <a:endParaRPr lang="en-GB" sz="1200" dirty="0"/>
          </a:p>
        </p:txBody>
      </p:sp>
      <p:sp>
        <p:nvSpPr>
          <p:cNvPr id="6" name="Tekstvak 5"/>
          <p:cNvSpPr txBox="1"/>
          <p:nvPr/>
        </p:nvSpPr>
        <p:spPr>
          <a:xfrm>
            <a:off x="3686175" y="5240000"/>
            <a:ext cx="557859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/>
              <a:t>mean </a:t>
            </a:r>
            <a:r>
              <a:rPr lang="en-GB" altLang="nl-BE" sz="1200" dirty="0" smtClean="0"/>
              <a:t>total polyunsaturated </a:t>
            </a:r>
            <a:r>
              <a:rPr lang="en-GB" altLang="nl-BE" sz="1200" dirty="0"/>
              <a:t>fatty acid</a:t>
            </a:r>
            <a:r>
              <a:rPr lang="en-GB" sz="1200" dirty="0" smtClean="0"/>
              <a:t> intake (g/day): (USNDB mean + ENDB mean)/2</a:t>
            </a:r>
            <a:endParaRPr lang="en-GB" sz="1200" dirty="0"/>
          </a:p>
        </p:txBody>
      </p:sp>
      <p:sp>
        <p:nvSpPr>
          <p:cNvPr id="7" name="Tekstvak 6"/>
          <p:cNvSpPr txBox="1"/>
          <p:nvPr/>
        </p:nvSpPr>
        <p:spPr>
          <a:xfrm rot="16200000">
            <a:off x="912995" y="3045766"/>
            <a:ext cx="3333752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m</a:t>
            </a:r>
            <a:r>
              <a:rPr lang="en-GB" sz="1200" dirty="0" smtClean="0"/>
              <a:t>ean difference in </a:t>
            </a:r>
            <a:r>
              <a:rPr lang="en-GB" altLang="nl-BE" sz="1200" dirty="0"/>
              <a:t>total polyunsaturated fatty acid</a:t>
            </a:r>
            <a:r>
              <a:rPr lang="en-GB" sz="1200" dirty="0" smtClean="0"/>
              <a:t> intake (g/day)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119668117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698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34117" y="1533504"/>
            <a:ext cx="6928260" cy="40781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9699" name="Tekstvak 3"/>
          <p:cNvSpPr txBox="1">
            <a:spLocks noChangeArrowheads="1"/>
          </p:cNvSpPr>
          <p:nvPr/>
        </p:nvSpPr>
        <p:spPr bwMode="auto">
          <a:xfrm>
            <a:off x="2033131" y="393049"/>
            <a:ext cx="8333463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nl-BE" sz="1200" b="1" dirty="0" smtClean="0"/>
              <a:t>Figures S2e</a:t>
            </a:r>
          </a:p>
          <a:p>
            <a:r>
              <a:rPr lang="en-GB" altLang="nl-BE" sz="1200" dirty="0" smtClean="0"/>
              <a:t>Bland-Altman plots for the </a:t>
            </a:r>
            <a:r>
              <a:rPr lang="en-GB" altLang="nl-BE" sz="1200" u="sng" dirty="0" smtClean="0"/>
              <a:t>dietary </a:t>
            </a:r>
            <a:r>
              <a:rPr lang="en-GB" altLang="nl-BE" sz="1200" u="sng" dirty="0"/>
              <a:t>questionnaire </a:t>
            </a:r>
            <a:r>
              <a:rPr lang="en-GB" altLang="nl-BE" sz="1200" dirty="0"/>
              <a:t>(DQ) data representing the mean differences and their limits of agreement for cholesterol intakes (mg/day) between the U.S. nutrient database </a:t>
            </a:r>
            <a:r>
              <a:rPr lang="en-GB" altLang="nl-BE" sz="1200" dirty="0" smtClean="0"/>
              <a:t>(USNDB) and </a:t>
            </a:r>
            <a:r>
              <a:rPr lang="en-GB" altLang="nl-BE" sz="1200" dirty="0"/>
              <a:t>the EPIC nutrient database (ENDB</a:t>
            </a:r>
            <a:r>
              <a:rPr lang="en-GB" altLang="nl-BE" sz="1200" dirty="0" smtClean="0"/>
              <a:t>). </a:t>
            </a:r>
            <a:r>
              <a:rPr lang="en-GB" altLang="nl-BE" sz="1200" dirty="0"/>
              <a:t>The mean difference is represented by the full line, upper and lower limit of agreement are presented by dotted lines.</a:t>
            </a:r>
          </a:p>
        </p:txBody>
      </p:sp>
      <p:sp>
        <p:nvSpPr>
          <p:cNvPr id="5" name="Tekstvak 4"/>
          <p:cNvSpPr txBox="1"/>
          <p:nvPr/>
        </p:nvSpPr>
        <p:spPr>
          <a:xfrm>
            <a:off x="3600450" y="5344775"/>
            <a:ext cx="557859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/>
              <a:t>mean </a:t>
            </a:r>
            <a:r>
              <a:rPr lang="en-GB" altLang="nl-BE" sz="1200" dirty="0"/>
              <a:t>cholesterol</a:t>
            </a:r>
            <a:r>
              <a:rPr lang="en-GB" sz="1200" dirty="0" smtClean="0"/>
              <a:t> intake (mg/day): (USNDB mean + ENDB mean)/2</a:t>
            </a:r>
            <a:endParaRPr lang="en-GB" sz="1200" dirty="0"/>
          </a:p>
        </p:txBody>
      </p:sp>
      <p:sp>
        <p:nvSpPr>
          <p:cNvPr id="6" name="Tekstvak 5"/>
          <p:cNvSpPr txBox="1"/>
          <p:nvPr/>
        </p:nvSpPr>
        <p:spPr>
          <a:xfrm rot="16200000">
            <a:off x="1079683" y="3095236"/>
            <a:ext cx="332422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m</a:t>
            </a:r>
            <a:r>
              <a:rPr lang="en-GB" sz="1200" dirty="0" smtClean="0"/>
              <a:t>ean difference in </a:t>
            </a:r>
            <a:r>
              <a:rPr lang="en-GB" altLang="nl-BE" sz="1200" dirty="0"/>
              <a:t>cholesterol</a:t>
            </a:r>
            <a:r>
              <a:rPr lang="en-GB" sz="1200" dirty="0" smtClean="0"/>
              <a:t> intake (mg/day)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289925945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2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17017" y="1596636"/>
            <a:ext cx="6927242" cy="40781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0723" name="Tekstvak 3"/>
          <p:cNvSpPr txBox="1">
            <a:spLocks noChangeArrowheads="1"/>
          </p:cNvSpPr>
          <p:nvPr/>
        </p:nvSpPr>
        <p:spPr bwMode="auto">
          <a:xfrm>
            <a:off x="2033131" y="393049"/>
            <a:ext cx="8333463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nl-BE" sz="1200" b="1" dirty="0" smtClean="0"/>
              <a:t>Figures S2f</a:t>
            </a:r>
          </a:p>
          <a:p>
            <a:r>
              <a:rPr lang="en-GB" altLang="nl-BE" sz="1200" dirty="0" smtClean="0"/>
              <a:t>Bland-Altman plots for the </a:t>
            </a:r>
            <a:r>
              <a:rPr lang="en-GB" altLang="nl-BE" sz="1200" u="sng" dirty="0" smtClean="0"/>
              <a:t>dietary </a:t>
            </a:r>
            <a:r>
              <a:rPr lang="en-GB" altLang="nl-BE" sz="1200" u="sng" dirty="0"/>
              <a:t>questionnaire </a:t>
            </a:r>
            <a:r>
              <a:rPr lang="en-GB" altLang="nl-BE" sz="1200" dirty="0"/>
              <a:t>(DQ) data representing the mean differences and their limits of agreement for sugar intakes (g/day) between the U.S. nutrient database </a:t>
            </a:r>
            <a:r>
              <a:rPr lang="en-GB" altLang="nl-BE" sz="1200" dirty="0" smtClean="0"/>
              <a:t>(USNDB) and </a:t>
            </a:r>
            <a:r>
              <a:rPr lang="en-GB" altLang="nl-BE" sz="1200" dirty="0"/>
              <a:t>the EPIC nutrient database (</a:t>
            </a:r>
            <a:r>
              <a:rPr lang="en-GB" altLang="nl-BE" sz="1200" dirty="0" smtClean="0"/>
              <a:t>ENDB). </a:t>
            </a:r>
            <a:r>
              <a:rPr lang="en-GB" altLang="nl-BE" sz="1200" dirty="0"/>
              <a:t>The mean difference is represented by the full line, upper and lower limit of agreement are presented by dotted lines.</a:t>
            </a:r>
          </a:p>
        </p:txBody>
      </p:sp>
      <p:sp>
        <p:nvSpPr>
          <p:cNvPr id="5" name="Tekstvak 4"/>
          <p:cNvSpPr txBox="1"/>
          <p:nvPr/>
        </p:nvSpPr>
        <p:spPr>
          <a:xfrm>
            <a:off x="3457575" y="5392400"/>
            <a:ext cx="557859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/>
              <a:t>mean sugar intake (g/day): (USNDB mean + ENDB mean)/2</a:t>
            </a:r>
            <a:endParaRPr lang="en-GB" sz="1200" dirty="0"/>
          </a:p>
        </p:txBody>
      </p:sp>
      <p:sp>
        <p:nvSpPr>
          <p:cNvPr id="6" name="Tekstvak 5"/>
          <p:cNvSpPr txBox="1"/>
          <p:nvPr/>
        </p:nvSpPr>
        <p:spPr>
          <a:xfrm rot="16200000">
            <a:off x="922520" y="3128575"/>
            <a:ext cx="339090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m</a:t>
            </a:r>
            <a:r>
              <a:rPr lang="en-GB" sz="1200" dirty="0" smtClean="0"/>
              <a:t>ean difference in sugar intake (g/day)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110079565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746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35556" y="1614965"/>
            <a:ext cx="6928260" cy="40781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1747" name="Tekstvak 3"/>
          <p:cNvSpPr txBox="1">
            <a:spLocks noChangeArrowheads="1"/>
          </p:cNvSpPr>
          <p:nvPr/>
        </p:nvSpPr>
        <p:spPr bwMode="auto">
          <a:xfrm>
            <a:off x="2033131" y="393049"/>
            <a:ext cx="8333463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nl-BE" sz="1200" b="1" dirty="0" smtClean="0"/>
              <a:t>Figures S2g</a:t>
            </a:r>
          </a:p>
          <a:p>
            <a:r>
              <a:rPr lang="en-GB" altLang="nl-BE" sz="1200" dirty="0" smtClean="0"/>
              <a:t>Bland-Altman plots for the </a:t>
            </a:r>
            <a:r>
              <a:rPr lang="en-GB" altLang="nl-BE" sz="1200" u="sng" dirty="0" smtClean="0"/>
              <a:t>dietary </a:t>
            </a:r>
            <a:r>
              <a:rPr lang="en-GB" altLang="nl-BE" sz="1200" u="sng" dirty="0"/>
              <a:t>questionnaire </a:t>
            </a:r>
            <a:r>
              <a:rPr lang="en-GB" altLang="nl-BE" sz="1200" dirty="0"/>
              <a:t>(DQ) data representing the mean differences and their limits of agreement for starch intakes (g/day) between the U.S. nutrient database </a:t>
            </a:r>
            <a:r>
              <a:rPr lang="en-GB" altLang="nl-BE" sz="1200" dirty="0" smtClean="0"/>
              <a:t>(USNDB) and </a:t>
            </a:r>
            <a:r>
              <a:rPr lang="en-GB" altLang="nl-BE" sz="1200" dirty="0"/>
              <a:t>the EPIC nutrient database (ENDB</a:t>
            </a:r>
            <a:r>
              <a:rPr lang="en-GB" altLang="nl-BE" sz="1200" dirty="0" smtClean="0"/>
              <a:t>). </a:t>
            </a:r>
            <a:r>
              <a:rPr lang="en-GB" altLang="nl-BE" sz="1200" dirty="0"/>
              <a:t>The mean difference is represented by the full line, upper and lower limit of agreement are presented by dotted lines.</a:t>
            </a:r>
          </a:p>
        </p:txBody>
      </p:sp>
      <p:sp>
        <p:nvSpPr>
          <p:cNvPr id="5" name="Tekstvak 4"/>
          <p:cNvSpPr txBox="1"/>
          <p:nvPr/>
        </p:nvSpPr>
        <p:spPr>
          <a:xfrm>
            <a:off x="3381375" y="5392400"/>
            <a:ext cx="557859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/>
              <a:t>mean fibre intake (g/day): (USNDB mean + ENDB mean)/2</a:t>
            </a:r>
            <a:endParaRPr lang="en-GB" sz="1200" dirty="0"/>
          </a:p>
        </p:txBody>
      </p:sp>
      <p:sp>
        <p:nvSpPr>
          <p:cNvPr id="6" name="Tekstvak 5"/>
          <p:cNvSpPr txBox="1"/>
          <p:nvPr/>
        </p:nvSpPr>
        <p:spPr>
          <a:xfrm rot="16200000">
            <a:off x="846320" y="3214299"/>
            <a:ext cx="333375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m</a:t>
            </a:r>
            <a:r>
              <a:rPr lang="en-GB" sz="1200" dirty="0" smtClean="0"/>
              <a:t>ean difference in fibre intake (g/day)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192179391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770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07642" y="1633294"/>
            <a:ext cx="6927242" cy="40781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2771" name="Tekstvak 3"/>
          <p:cNvSpPr txBox="1">
            <a:spLocks noChangeArrowheads="1"/>
          </p:cNvSpPr>
          <p:nvPr/>
        </p:nvSpPr>
        <p:spPr bwMode="auto">
          <a:xfrm>
            <a:off x="2033131" y="393049"/>
            <a:ext cx="8333463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nl-BE" sz="1200" b="1" dirty="0" smtClean="0"/>
              <a:t>Figures S2h</a:t>
            </a:r>
          </a:p>
          <a:p>
            <a:r>
              <a:rPr lang="en-GB" altLang="nl-BE" sz="1200" dirty="0" smtClean="0"/>
              <a:t>Bland-Altman plots for the </a:t>
            </a:r>
            <a:r>
              <a:rPr lang="en-GB" altLang="nl-BE" sz="1200" u="sng" dirty="0" smtClean="0"/>
              <a:t>dietary </a:t>
            </a:r>
            <a:r>
              <a:rPr lang="en-GB" altLang="nl-BE" sz="1200" u="sng" dirty="0"/>
              <a:t>questionnaire </a:t>
            </a:r>
            <a:r>
              <a:rPr lang="en-GB" altLang="nl-BE" sz="1200" dirty="0"/>
              <a:t>(DQ) data representing the mean differences and their limits of agreement for dietary </a:t>
            </a:r>
            <a:r>
              <a:rPr lang="en-GB" altLang="nl-BE" sz="1200" dirty="0" smtClean="0"/>
              <a:t>fibre </a:t>
            </a:r>
            <a:r>
              <a:rPr lang="en-GB" altLang="nl-BE" sz="1200" dirty="0"/>
              <a:t>intakes (g/day) between the U.S. nutrient database </a:t>
            </a:r>
            <a:r>
              <a:rPr lang="en-GB" altLang="nl-BE" sz="1200" dirty="0" smtClean="0"/>
              <a:t>(USNDB) </a:t>
            </a:r>
            <a:r>
              <a:rPr lang="en-GB" altLang="nl-BE" sz="1200" dirty="0"/>
              <a:t>and the EPIC nutrient database (ENDB</a:t>
            </a:r>
            <a:r>
              <a:rPr lang="en-GB" altLang="nl-BE" sz="1200" dirty="0" smtClean="0"/>
              <a:t>). </a:t>
            </a:r>
            <a:r>
              <a:rPr lang="en-GB" altLang="nl-BE" sz="1200" dirty="0"/>
              <a:t>The mean difference is represented by the full line, upper and lower limit of agreement are presented by dotted lines.</a:t>
            </a:r>
          </a:p>
        </p:txBody>
      </p:sp>
      <p:sp>
        <p:nvSpPr>
          <p:cNvPr id="5" name="Tekstvak 4"/>
          <p:cNvSpPr txBox="1"/>
          <p:nvPr/>
        </p:nvSpPr>
        <p:spPr>
          <a:xfrm>
            <a:off x="3495675" y="5382875"/>
            <a:ext cx="557859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/>
              <a:t>mean dietary fibre intake (g/day): (USNDB mean + ENDB mean)/2</a:t>
            </a:r>
            <a:endParaRPr lang="en-GB" sz="1200" dirty="0"/>
          </a:p>
        </p:txBody>
      </p:sp>
      <p:sp>
        <p:nvSpPr>
          <p:cNvPr id="6" name="Tekstvak 5"/>
          <p:cNvSpPr txBox="1"/>
          <p:nvPr/>
        </p:nvSpPr>
        <p:spPr>
          <a:xfrm rot="16200000">
            <a:off x="1036820" y="3280974"/>
            <a:ext cx="333375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m</a:t>
            </a:r>
            <a:r>
              <a:rPr lang="en-GB" sz="1200" dirty="0" smtClean="0"/>
              <a:t>ean difference in dietary fibre intake (g/day)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73227247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794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6806" y="1434733"/>
            <a:ext cx="6927242" cy="40781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3795" name="Tekstvak 3"/>
          <p:cNvSpPr txBox="1">
            <a:spLocks noChangeArrowheads="1"/>
          </p:cNvSpPr>
          <p:nvPr/>
        </p:nvSpPr>
        <p:spPr bwMode="auto">
          <a:xfrm>
            <a:off x="2033131" y="393049"/>
            <a:ext cx="8333463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nl-BE" sz="1200" b="1" dirty="0" smtClean="0"/>
              <a:t>Figures S2i</a:t>
            </a:r>
          </a:p>
          <a:p>
            <a:r>
              <a:rPr lang="en-GB" altLang="nl-BE" sz="1200" dirty="0" smtClean="0"/>
              <a:t>Bland-Altman plots for the </a:t>
            </a:r>
            <a:r>
              <a:rPr lang="en-GB" altLang="nl-BE" sz="1200" u="sng" dirty="0" smtClean="0"/>
              <a:t>dietary </a:t>
            </a:r>
            <a:r>
              <a:rPr lang="en-GB" altLang="nl-BE" sz="1200" u="sng" dirty="0"/>
              <a:t>questionnaire </a:t>
            </a:r>
            <a:r>
              <a:rPr lang="en-GB" altLang="nl-BE" sz="1200" dirty="0"/>
              <a:t>(DQ) data representing the mean differences and their limits of agreement for calcium intakes (mg/day) between the U.S. nutrient database </a:t>
            </a:r>
            <a:r>
              <a:rPr lang="en-GB" altLang="nl-BE" sz="1200" dirty="0" smtClean="0"/>
              <a:t>(USNDB) </a:t>
            </a:r>
            <a:r>
              <a:rPr lang="en-GB" altLang="nl-BE" sz="1200" dirty="0"/>
              <a:t>and the EPIC nutrient database (</a:t>
            </a:r>
            <a:r>
              <a:rPr lang="en-GB" altLang="nl-BE" sz="1200" dirty="0" smtClean="0"/>
              <a:t>ENDB). The </a:t>
            </a:r>
            <a:r>
              <a:rPr lang="en-GB" altLang="nl-BE" sz="1200" dirty="0"/>
              <a:t>mean difference is represented by the full line, upper and lower limit of agreement are presented by dotted lines.</a:t>
            </a:r>
          </a:p>
        </p:txBody>
      </p:sp>
      <p:sp>
        <p:nvSpPr>
          <p:cNvPr id="5" name="Tekstvak 4"/>
          <p:cNvSpPr txBox="1"/>
          <p:nvPr/>
        </p:nvSpPr>
        <p:spPr>
          <a:xfrm>
            <a:off x="3686175" y="5240000"/>
            <a:ext cx="557859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/>
              <a:t>mean calcium intake (mg/day): (USNDB mean + ENDB mean)/2</a:t>
            </a:r>
            <a:endParaRPr lang="en-GB" sz="1200" dirty="0"/>
          </a:p>
        </p:txBody>
      </p:sp>
      <p:sp>
        <p:nvSpPr>
          <p:cNvPr id="6" name="Tekstvak 5"/>
          <p:cNvSpPr txBox="1"/>
          <p:nvPr/>
        </p:nvSpPr>
        <p:spPr>
          <a:xfrm rot="16200000">
            <a:off x="998720" y="3099999"/>
            <a:ext cx="333375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m</a:t>
            </a:r>
            <a:r>
              <a:rPr lang="en-GB" sz="1200" dirty="0" smtClean="0"/>
              <a:t>ean difference in calcium intake (mg/day)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2152360552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0</TotalTime>
  <Words>2148</Words>
  <Application>Microsoft Office PowerPoint</Application>
  <PresentationFormat>Breedbeeld</PresentationFormat>
  <Paragraphs>95</Paragraphs>
  <Slides>23</Slides>
  <Notes>0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3</vt:i4>
      </vt:variant>
      <vt:variant>
        <vt:lpstr>Thema</vt:lpstr>
      </vt:variant>
      <vt:variant>
        <vt:i4>1</vt:i4>
      </vt:variant>
      <vt:variant>
        <vt:lpstr>Diatitels</vt:lpstr>
      </vt:variant>
      <vt:variant>
        <vt:i4>23</vt:i4>
      </vt:variant>
    </vt:vector>
  </HeadingPairs>
  <TitlesOfParts>
    <vt:vector size="27" baseType="lpstr">
      <vt:lpstr>Arial</vt:lpstr>
      <vt:lpstr>Calibri</vt:lpstr>
      <vt:lpstr>Calibri Light</vt:lpstr>
      <vt:lpstr>Kantoorthema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</vt:vector>
  </TitlesOfParts>
  <Company>UGen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Heleen Van Puyvelde</dc:creator>
  <cp:lastModifiedBy>Heleen Van Puyvelde</cp:lastModifiedBy>
  <cp:revision>12</cp:revision>
  <dcterms:created xsi:type="dcterms:W3CDTF">2020-08-06T12:26:42Z</dcterms:created>
  <dcterms:modified xsi:type="dcterms:W3CDTF">2020-09-09T08:47:06Z</dcterms:modified>
</cp:coreProperties>
</file>